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030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3336" y="-2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C8ADA-BEAE-45DB-A0A2-F08A848A49E0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F48BF-B550-4B28-ADE6-A0E21880190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605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C8ADA-BEAE-45DB-A0A2-F08A848A49E0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F48BF-B550-4B28-ADE6-A0E21880190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889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C8ADA-BEAE-45DB-A0A2-F08A848A49E0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F48BF-B550-4B28-ADE6-A0E21880190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544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C8ADA-BEAE-45DB-A0A2-F08A848A49E0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F48BF-B550-4B28-ADE6-A0E21880190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05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C8ADA-BEAE-45DB-A0A2-F08A848A49E0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F48BF-B550-4B28-ADE6-A0E21880190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112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C8ADA-BEAE-45DB-A0A2-F08A848A49E0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F48BF-B550-4B28-ADE6-A0E21880190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372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C8ADA-BEAE-45DB-A0A2-F08A848A49E0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F48BF-B550-4B28-ADE6-A0E21880190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544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C8ADA-BEAE-45DB-A0A2-F08A848A49E0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F48BF-B550-4B28-ADE6-A0E21880190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834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C8ADA-BEAE-45DB-A0A2-F08A848A49E0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F48BF-B550-4B28-ADE6-A0E21880190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839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C8ADA-BEAE-45DB-A0A2-F08A848A49E0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F48BF-B550-4B28-ADE6-A0E21880190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74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C8ADA-BEAE-45DB-A0A2-F08A848A49E0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F48BF-B550-4B28-ADE6-A0E21880190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656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CC8ADA-BEAE-45DB-A0A2-F08A848A49E0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CF48BF-B550-4B28-ADE6-A0E21880190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599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8400" y="1647105"/>
            <a:ext cx="1823162" cy="66402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4207" y="3444919"/>
            <a:ext cx="1973755" cy="84683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8300" y="2374694"/>
            <a:ext cx="1712491" cy="50675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4704798" y="757680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MOLM-1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3794" y="4437618"/>
            <a:ext cx="1625119" cy="500933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1" name="Rectangle 10"/>
          <p:cNvSpPr/>
          <p:nvPr/>
        </p:nvSpPr>
        <p:spPr>
          <a:xfrm>
            <a:off x="4598157" y="2518289"/>
            <a:ext cx="149502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4548840" y="4506461"/>
            <a:ext cx="149502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4538134" y="3778652"/>
            <a:ext cx="1548875" cy="26766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4894488" y="1351774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5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4535654" y="1808974"/>
            <a:ext cx="1630753" cy="3151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1725977" y="75924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Jurkat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431" y="1529406"/>
            <a:ext cx="3472433" cy="775036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23" name="TextBox 22"/>
          <p:cNvSpPr txBox="1"/>
          <p:nvPr/>
        </p:nvSpPr>
        <p:spPr>
          <a:xfrm>
            <a:off x="2457644" y="1226571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5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2121338" y="1833090"/>
            <a:ext cx="1548875" cy="26766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724" y="4385571"/>
            <a:ext cx="3371228" cy="713779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659" y="2393145"/>
            <a:ext cx="3587303" cy="59446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28" name="Rectangle 27"/>
          <p:cNvSpPr/>
          <p:nvPr/>
        </p:nvSpPr>
        <p:spPr>
          <a:xfrm>
            <a:off x="2157632" y="2507429"/>
            <a:ext cx="1548875" cy="26766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2064487" y="4470360"/>
            <a:ext cx="1700508" cy="3787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055" y="3624609"/>
            <a:ext cx="3650284" cy="69327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32" name="Rectangle 31"/>
          <p:cNvSpPr/>
          <p:nvPr/>
        </p:nvSpPr>
        <p:spPr>
          <a:xfrm>
            <a:off x="2113758" y="3766354"/>
            <a:ext cx="1548875" cy="26766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16"/>
          <p:cNvSpPr txBox="1"/>
          <p:nvPr/>
        </p:nvSpPr>
        <p:spPr>
          <a:xfrm>
            <a:off x="4894488" y="3152836"/>
            <a:ext cx="8579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7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16"/>
          <p:cNvSpPr txBox="1"/>
          <p:nvPr/>
        </p:nvSpPr>
        <p:spPr>
          <a:xfrm>
            <a:off x="2554386" y="3333049"/>
            <a:ext cx="8579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7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 Box 2"/>
          <p:cNvSpPr txBox="1">
            <a:spLocks noChangeArrowheads="1"/>
          </p:cNvSpPr>
          <p:nvPr/>
        </p:nvSpPr>
        <p:spPr bwMode="auto">
          <a:xfrm>
            <a:off x="-8872" y="-4574"/>
            <a:ext cx="262123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2000" b="1" dirty="0" smtClean="0"/>
              <a:t>Supporting Figure 8</a:t>
            </a:r>
            <a:endParaRPr lang="en-US" sz="2000" b="1" dirty="0"/>
          </a:p>
        </p:txBody>
      </p:sp>
      <p:sp>
        <p:nvSpPr>
          <p:cNvPr id="30" name="Textfeld 29"/>
          <p:cNvSpPr txBox="1"/>
          <p:nvPr/>
        </p:nvSpPr>
        <p:spPr>
          <a:xfrm>
            <a:off x="188640" y="5528371"/>
            <a:ext cx="648072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+mj-lt"/>
              </a:rPr>
              <a:t>Figure S8. </a:t>
            </a:r>
            <a:r>
              <a:rPr lang="en-US" sz="1100" dirty="0" smtClean="0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ll immunoblot images. Black boxes indicate the cropped portion of each immunoblot shown in the corresponding main figures.</a:t>
            </a:r>
            <a:endParaRPr lang="en-US" sz="1100" dirty="0" smtClean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476664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</Words>
  <Application>Microsoft Office PowerPoint</Application>
  <PresentationFormat>A4-Papier (210 x 297 mm)</PresentationFormat>
  <Paragraphs>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>Leibniz Institut für Alternsforschu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 Marx</dc:creator>
  <cp:lastModifiedBy>Sonnemann, Jürgen</cp:lastModifiedBy>
  <cp:revision>13</cp:revision>
  <dcterms:created xsi:type="dcterms:W3CDTF">2022-03-15T08:07:04Z</dcterms:created>
  <dcterms:modified xsi:type="dcterms:W3CDTF">2022-03-15T10:13:06Z</dcterms:modified>
</cp:coreProperties>
</file>